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73F5A87F-2F85-4A05-BE8C-6D8FAF6F94A8}">
          <p14:sldIdLst>
            <p14:sldId id="282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6" d="100"/>
          <a:sy n="86" d="100"/>
        </p:scale>
        <p:origin x="33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5999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1" indent="0" algn="ctr">
              <a:buNone/>
              <a:defRPr sz="2000"/>
            </a:lvl2pPr>
            <a:lvl3pPr marL="914361" indent="0" algn="ctr">
              <a:buNone/>
              <a:defRPr sz="1800"/>
            </a:lvl3pPr>
            <a:lvl4pPr marL="1371543" indent="0" algn="ctr">
              <a:buNone/>
              <a:defRPr sz="1600"/>
            </a:lvl4pPr>
            <a:lvl5pPr marL="1828724" indent="0" algn="ctr">
              <a:buNone/>
              <a:defRPr sz="1600"/>
            </a:lvl5pPr>
            <a:lvl6pPr marL="2285904" indent="0" algn="ctr">
              <a:buNone/>
              <a:defRPr sz="1600"/>
            </a:lvl6pPr>
            <a:lvl7pPr marL="2743085" indent="0" algn="ctr">
              <a:buNone/>
              <a:defRPr sz="1600"/>
            </a:lvl7pPr>
            <a:lvl8pPr marL="3200266" indent="0" algn="ctr">
              <a:buNone/>
              <a:defRPr sz="1600"/>
            </a:lvl8pPr>
            <a:lvl9pPr marL="3657447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528C8-3F90-494E-B2A4-DADF44D81158}" type="datetimeFigureOut">
              <a:rPr lang="en-GB" smtClean="0"/>
              <a:t>23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9E3CE-ADF9-45F9-939B-133BF1DE35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12837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528C8-3F90-494E-B2A4-DADF44D81158}" type="datetimeFigureOut">
              <a:rPr lang="en-GB" smtClean="0"/>
              <a:t>23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9E3CE-ADF9-45F9-939B-133BF1DE35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8284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528C8-3F90-494E-B2A4-DADF44D81158}" type="datetimeFigureOut">
              <a:rPr lang="en-GB" smtClean="0"/>
              <a:t>23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9E3CE-ADF9-45F9-939B-133BF1DE35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18585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528C8-3F90-494E-B2A4-DADF44D81158}" type="datetimeFigureOut">
              <a:rPr lang="en-GB" smtClean="0"/>
              <a:t>23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9E3CE-ADF9-45F9-939B-133BF1DE35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6034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5999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2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0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8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4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528C8-3F90-494E-B2A4-DADF44D81158}" type="datetimeFigureOut">
              <a:rPr lang="en-GB" smtClean="0"/>
              <a:t>23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9E3CE-ADF9-45F9-939B-133BF1DE35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902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528C8-3F90-494E-B2A4-DADF44D81158}" type="datetimeFigureOut">
              <a:rPr lang="en-GB" smtClean="0"/>
              <a:t>23/1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9E3CE-ADF9-45F9-939B-133BF1DE35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7787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6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1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4" indent="0">
              <a:buNone/>
              <a:defRPr sz="1600" b="1"/>
            </a:lvl5pPr>
            <a:lvl6pPr marL="2285904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1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4" indent="0">
              <a:buNone/>
              <a:defRPr sz="1600" b="1"/>
            </a:lvl5pPr>
            <a:lvl6pPr marL="2285904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528C8-3F90-494E-B2A4-DADF44D81158}" type="datetimeFigureOut">
              <a:rPr lang="en-GB" smtClean="0"/>
              <a:t>23/12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9E3CE-ADF9-45F9-939B-133BF1DE35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1172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528C8-3F90-494E-B2A4-DADF44D81158}" type="datetimeFigureOut">
              <a:rPr lang="en-GB" smtClean="0"/>
              <a:t>23/12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9E3CE-ADF9-45F9-939B-133BF1DE35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8349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528C8-3F90-494E-B2A4-DADF44D81158}" type="datetimeFigureOut">
              <a:rPr lang="en-GB" smtClean="0"/>
              <a:t>23/12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9E3CE-ADF9-45F9-939B-133BF1DE35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87322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1" indent="0">
              <a:buNone/>
              <a:defRPr sz="1200"/>
            </a:lvl3pPr>
            <a:lvl4pPr marL="1371543" indent="0">
              <a:buNone/>
              <a:defRPr sz="1000"/>
            </a:lvl4pPr>
            <a:lvl5pPr marL="1828724" indent="0">
              <a:buNone/>
              <a:defRPr sz="1000"/>
            </a:lvl5pPr>
            <a:lvl6pPr marL="2285904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528C8-3F90-494E-B2A4-DADF44D81158}" type="datetimeFigureOut">
              <a:rPr lang="en-GB" smtClean="0"/>
              <a:t>23/1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9E3CE-ADF9-45F9-939B-133BF1DE35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9664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1" indent="0">
              <a:buNone/>
              <a:defRPr sz="2800"/>
            </a:lvl2pPr>
            <a:lvl3pPr marL="914361" indent="0">
              <a:buNone/>
              <a:defRPr sz="2400"/>
            </a:lvl3pPr>
            <a:lvl4pPr marL="1371543" indent="0">
              <a:buNone/>
              <a:defRPr sz="2000"/>
            </a:lvl4pPr>
            <a:lvl5pPr marL="1828724" indent="0">
              <a:buNone/>
              <a:defRPr sz="2000"/>
            </a:lvl5pPr>
            <a:lvl6pPr marL="2285904" indent="0">
              <a:buNone/>
              <a:defRPr sz="2000"/>
            </a:lvl6pPr>
            <a:lvl7pPr marL="2743085" indent="0">
              <a:buNone/>
              <a:defRPr sz="2000"/>
            </a:lvl7pPr>
            <a:lvl8pPr marL="3200266" indent="0">
              <a:buNone/>
              <a:defRPr sz="2000"/>
            </a:lvl8pPr>
            <a:lvl9pPr marL="3657447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1" indent="0">
              <a:buNone/>
              <a:defRPr sz="1200"/>
            </a:lvl3pPr>
            <a:lvl4pPr marL="1371543" indent="0">
              <a:buNone/>
              <a:defRPr sz="1000"/>
            </a:lvl4pPr>
            <a:lvl5pPr marL="1828724" indent="0">
              <a:buNone/>
              <a:defRPr sz="1000"/>
            </a:lvl5pPr>
            <a:lvl6pPr marL="2285904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528C8-3F90-494E-B2A4-DADF44D81158}" type="datetimeFigureOut">
              <a:rPr lang="en-GB" smtClean="0"/>
              <a:t>23/1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9E3CE-ADF9-45F9-939B-133BF1DE35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23667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3528C8-3F90-494E-B2A4-DADF44D81158}" type="datetimeFigureOut">
              <a:rPr lang="en-GB" smtClean="0"/>
              <a:t>23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E9E3CE-ADF9-45F9-939B-133BF1DE35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0224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6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72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2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3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4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5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76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57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37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1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3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4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4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85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66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47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48"/>
          <p:cNvGrpSpPr>
            <a:grpSpLocks noChangeAspect="1"/>
          </p:cNvGrpSpPr>
          <p:nvPr/>
        </p:nvGrpSpPr>
        <p:grpSpPr>
          <a:xfrm>
            <a:off x="-92818" y="1"/>
            <a:ext cx="10983732" cy="6206626"/>
            <a:chOff x="-92819" y="0"/>
            <a:chExt cx="11835639" cy="668801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50009" y="702194"/>
              <a:ext cx="2621762" cy="1958788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94000"/>
                      </a14:imgEffect>
                      <a14:imgEffect>
                        <a14:brightnessContrast bright="30000" contrast="3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3562" y="702582"/>
              <a:ext cx="2621762" cy="1958788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94000"/>
                      </a14:imgEffect>
                      <a14:imgEffect>
                        <a14:brightnessContrast bright="37000" contrast="6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74665" y="4720470"/>
              <a:ext cx="2633486" cy="1967547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1000" contrast="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74904" y="4707023"/>
              <a:ext cx="2633486" cy="1967547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94000"/>
                      </a14:imgEffect>
                      <a14:imgEffect>
                        <a14:brightnessContrast bright="22000" contrast="4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3562" y="4699676"/>
              <a:ext cx="2621244" cy="195840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2000" contrast="1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64179" y="4700064"/>
              <a:ext cx="2621762" cy="1958788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2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61112" y="702582"/>
              <a:ext cx="2621243" cy="1958400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sharpenSoften amount="94000"/>
                      </a14:imgEffect>
                      <a14:imgEffect>
                        <a14:brightnessContrast bright="28000" contras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74665" y="702582"/>
              <a:ext cx="2621762" cy="1958788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3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58975" y="2701323"/>
              <a:ext cx="2621243" cy="1958400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sharpenSoften amount="94000"/>
                      </a14:imgEffect>
                      <a14:imgEffect>
                        <a14:brightnessContrast bright="16000" contras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74665" y="2701324"/>
              <a:ext cx="2621762" cy="1958788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3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56734" y="2701323"/>
              <a:ext cx="2621243" cy="1958400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sharpenSoften amount="94000"/>
                      </a14:imgEffect>
                      <a14:imgEffect>
                        <a14:brightnessContrast bright="29000" contrast="3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4081" y="2701323"/>
              <a:ext cx="2621243" cy="1958400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977629" y="0"/>
              <a:ext cx="38143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/>
                <a:t>Aligned </a:t>
              </a:r>
              <a:r>
                <a:rPr lang="en-GB" sz="1600" b="1" dirty="0" err="1"/>
                <a:t>nanofibres</a:t>
              </a:r>
              <a:endParaRPr lang="en-GB" sz="160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167727" y="0"/>
              <a:ext cx="38143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/>
                <a:t>Random </a:t>
              </a:r>
              <a:r>
                <a:rPr lang="en-GB" sz="1600" b="1" dirty="0" err="1"/>
                <a:t>nanofibres</a:t>
              </a:r>
              <a:endParaRPr lang="en-GB" sz="160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63562" y="350903"/>
              <a:ext cx="26212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/>
                <a:t>Phase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884806" y="348603"/>
              <a:ext cx="26212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/>
                <a:t>Fluorescence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354720" y="350903"/>
              <a:ext cx="26212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/>
                <a:t>Phase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8975964" y="348603"/>
              <a:ext cx="26212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/>
                <a:t>Fluorescence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964179" y="2200665"/>
              <a:ext cx="73026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6BFF03"/>
                  </a:solidFill>
                  <a:latin typeface="Cambria" panose="02040503050406030204" pitchFamily="18" charset="0"/>
                </a:rPr>
                <a:t>GFAP</a:t>
              </a:r>
            </a:p>
            <a:p>
              <a:r>
                <a:rPr lang="en-GB" sz="1100" b="1" dirty="0">
                  <a:solidFill>
                    <a:srgbClr val="00B0F0"/>
                  </a:solidFill>
                  <a:latin typeface="Cambria" panose="02040503050406030204" pitchFamily="18" charset="0"/>
                </a:rPr>
                <a:t>DAPI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9058975" y="2183804"/>
              <a:ext cx="73026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6BFF03"/>
                  </a:solidFill>
                  <a:latin typeface="Cambria" panose="02040503050406030204" pitchFamily="18" charset="0"/>
                </a:rPr>
                <a:t>GFAP</a:t>
              </a:r>
            </a:p>
            <a:p>
              <a:r>
                <a:rPr lang="en-GB" sz="1100" b="1" dirty="0">
                  <a:solidFill>
                    <a:srgbClr val="00B0F0"/>
                  </a:solidFill>
                  <a:latin typeface="Cambria" panose="02040503050406030204" pitchFamily="18" charset="0"/>
                </a:rPr>
                <a:t>DAPI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964179" y="4218228"/>
              <a:ext cx="73026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FF0000"/>
                  </a:solidFill>
                  <a:latin typeface="Cambria" panose="02040503050406030204" pitchFamily="18" charset="0"/>
                </a:rPr>
                <a:t>Tuj-1</a:t>
              </a:r>
            </a:p>
            <a:p>
              <a:r>
                <a:rPr lang="en-GB" sz="1100" b="1" dirty="0">
                  <a:solidFill>
                    <a:srgbClr val="00B0F0"/>
                  </a:solidFill>
                  <a:latin typeface="Cambria" panose="02040503050406030204" pitchFamily="18" charset="0"/>
                </a:rPr>
                <a:t>DAPI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9074904" y="4198058"/>
              <a:ext cx="73026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FF0000"/>
                  </a:solidFill>
                  <a:latin typeface="Cambria" panose="02040503050406030204" pitchFamily="18" charset="0"/>
                </a:rPr>
                <a:t>Tuj-1</a:t>
              </a:r>
            </a:p>
            <a:p>
              <a:r>
                <a:rPr lang="en-GB" sz="1100" b="1" dirty="0">
                  <a:solidFill>
                    <a:srgbClr val="00B0F0"/>
                  </a:solidFill>
                  <a:latin typeface="Cambria" panose="02040503050406030204" pitchFamily="18" charset="0"/>
                </a:rPr>
                <a:t>DAPI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961834" y="6188196"/>
              <a:ext cx="78921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6BFF03"/>
                  </a:solidFill>
                  <a:latin typeface="Cambria" panose="02040503050406030204" pitchFamily="18" charset="0"/>
                </a:rPr>
                <a:t>MBP</a:t>
              </a:r>
            </a:p>
            <a:p>
              <a:r>
                <a:rPr lang="en-GB" sz="1100" b="1" dirty="0">
                  <a:solidFill>
                    <a:srgbClr val="00B0F0"/>
                  </a:solidFill>
                  <a:latin typeface="Cambria" panose="02040503050406030204" pitchFamily="18" charset="0"/>
                </a:rPr>
                <a:t>DAPI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9058975" y="6212905"/>
              <a:ext cx="78921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6BFF03"/>
                  </a:solidFill>
                  <a:latin typeface="Cambria" panose="02040503050406030204" pitchFamily="18" charset="0"/>
                </a:rPr>
                <a:t>MBP</a:t>
              </a:r>
            </a:p>
            <a:p>
              <a:r>
                <a:rPr lang="en-GB" sz="1100" b="1" dirty="0">
                  <a:solidFill>
                    <a:srgbClr val="00B0F0"/>
                  </a:solidFill>
                  <a:latin typeface="Cambria" panose="02040503050406030204" pitchFamily="18" charset="0"/>
                </a:rPr>
                <a:t>DAPI</a:t>
              </a:r>
            </a:p>
          </p:txBody>
        </p:sp>
        <p:cxnSp>
          <p:nvCxnSpPr>
            <p:cNvPr id="7" name="Straight Connector 6"/>
            <p:cNvCxnSpPr/>
            <p:nvPr/>
          </p:nvCxnSpPr>
          <p:spPr>
            <a:xfrm flipV="1">
              <a:off x="4998510" y="2538664"/>
              <a:ext cx="414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4877820" y="2241495"/>
              <a:ext cx="730265" cy="281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chemeClr val="bg1"/>
                  </a:solidFill>
                  <a:latin typeface="Cambria" panose="02040503050406030204" pitchFamily="18" charset="0"/>
                </a:rPr>
                <a:t>50 µm</a:t>
              </a:r>
            </a:p>
          </p:txBody>
        </p:sp>
        <p:cxnSp>
          <p:nvCxnSpPr>
            <p:cNvPr id="30" name="Straight Connector 29"/>
            <p:cNvCxnSpPr/>
            <p:nvPr/>
          </p:nvCxnSpPr>
          <p:spPr>
            <a:xfrm flipV="1">
              <a:off x="5015633" y="4515397"/>
              <a:ext cx="414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4894943" y="4218228"/>
              <a:ext cx="730265" cy="281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chemeClr val="bg1"/>
                  </a:solidFill>
                  <a:latin typeface="Cambria" panose="02040503050406030204" pitchFamily="18" charset="0"/>
                </a:rPr>
                <a:t>50 µm</a:t>
              </a:r>
            </a:p>
          </p:txBody>
        </p:sp>
        <p:cxnSp>
          <p:nvCxnSpPr>
            <p:cNvPr id="32" name="Straight Connector 31"/>
            <p:cNvCxnSpPr/>
            <p:nvPr/>
          </p:nvCxnSpPr>
          <p:spPr>
            <a:xfrm flipV="1">
              <a:off x="4998510" y="6518126"/>
              <a:ext cx="414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4877820" y="6220957"/>
              <a:ext cx="730265" cy="281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chemeClr val="bg1"/>
                  </a:solidFill>
                  <a:latin typeface="Cambria" panose="02040503050406030204" pitchFamily="18" charset="0"/>
                </a:rPr>
                <a:t>50 µm</a:t>
              </a:r>
            </a:p>
          </p:txBody>
        </p:sp>
        <p:cxnSp>
          <p:nvCxnSpPr>
            <p:cNvPr id="34" name="Straight Connector 33"/>
            <p:cNvCxnSpPr/>
            <p:nvPr/>
          </p:nvCxnSpPr>
          <p:spPr>
            <a:xfrm flipV="1">
              <a:off x="11116122" y="2538665"/>
              <a:ext cx="414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10995432" y="2241496"/>
              <a:ext cx="730265" cy="281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chemeClr val="bg1"/>
                  </a:solidFill>
                  <a:latin typeface="Cambria" panose="02040503050406030204" pitchFamily="18" charset="0"/>
                </a:rPr>
                <a:t>50 µm</a:t>
              </a:r>
            </a:p>
          </p:txBody>
        </p:sp>
        <p:cxnSp>
          <p:nvCxnSpPr>
            <p:cNvPr id="36" name="Straight Connector 35"/>
            <p:cNvCxnSpPr/>
            <p:nvPr/>
          </p:nvCxnSpPr>
          <p:spPr>
            <a:xfrm flipV="1">
              <a:off x="11133245" y="4515398"/>
              <a:ext cx="414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>
              <a:off x="11012555" y="4218229"/>
              <a:ext cx="730265" cy="281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chemeClr val="bg1"/>
                  </a:solidFill>
                  <a:latin typeface="Cambria" panose="02040503050406030204" pitchFamily="18" charset="0"/>
                </a:rPr>
                <a:t>50 µm</a:t>
              </a:r>
            </a:p>
          </p:txBody>
        </p:sp>
        <p:cxnSp>
          <p:nvCxnSpPr>
            <p:cNvPr id="38" name="Straight Connector 37"/>
            <p:cNvCxnSpPr/>
            <p:nvPr/>
          </p:nvCxnSpPr>
          <p:spPr>
            <a:xfrm flipV="1">
              <a:off x="11116122" y="6518127"/>
              <a:ext cx="414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>
              <a:off x="10995432" y="6220958"/>
              <a:ext cx="730265" cy="281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chemeClr val="bg1"/>
                  </a:solidFill>
                  <a:latin typeface="Cambria" panose="02040503050406030204" pitchFamily="18" charset="0"/>
                </a:rPr>
                <a:t>50 µm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 rot="16200000">
              <a:off x="-838768" y="1506137"/>
              <a:ext cx="18612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/>
                <a:t>Astrocytes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-814878" y="3515833"/>
              <a:ext cx="18612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/>
                <a:t>Neurons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 rot="16200000">
              <a:off x="-814878" y="5498503"/>
              <a:ext cx="18612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/>
                <a:t>Oligodendrocytes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 rot="16200000">
              <a:off x="5249082" y="1542214"/>
              <a:ext cx="18612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/>
                <a:t>Astrocytes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 rot="16200000">
              <a:off x="5272972" y="3551910"/>
              <a:ext cx="18612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/>
                <a:t>Neurons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 rot="16200000">
              <a:off x="5272972" y="5534580"/>
              <a:ext cx="18612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/>
                <a:t>Oligodendrocytes</a:t>
              </a:r>
            </a:p>
          </p:txBody>
        </p:sp>
        <p:cxnSp>
          <p:nvCxnSpPr>
            <p:cNvPr id="47" name="Straight Connector 46"/>
            <p:cNvCxnSpPr/>
            <p:nvPr/>
          </p:nvCxnSpPr>
          <p:spPr>
            <a:xfrm>
              <a:off x="263562" y="336883"/>
              <a:ext cx="524248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6386907" y="337248"/>
              <a:ext cx="524248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0" name="TextBox 49"/>
          <p:cNvSpPr txBox="1"/>
          <p:nvPr/>
        </p:nvSpPr>
        <p:spPr>
          <a:xfrm>
            <a:off x="100726" y="6250436"/>
            <a:ext cx="1077429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upplementary Figure S1.</a:t>
            </a:r>
            <a:r>
              <a:rPr lang="en-GB" sz="1600" dirty="0"/>
              <a:t> Representative images showing counterpart phase and fluorescence images of aligned and random nanofibers. Each stain depicts a different cell type in a differentiated population of NSCs as indicated on the figure.</a:t>
            </a:r>
          </a:p>
        </p:txBody>
      </p:sp>
    </p:spTree>
    <p:extLst>
      <p:ext uri="{BB962C8B-B14F-4D97-AF65-F5344CB8AC3E}">
        <p14:creationId xmlns:p14="http://schemas.microsoft.com/office/powerpoint/2010/main" val="3196910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24</TotalTime>
  <Words>75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Adams</dc:creator>
  <cp:lastModifiedBy>MDPI</cp:lastModifiedBy>
  <cp:revision>69</cp:revision>
  <dcterms:created xsi:type="dcterms:W3CDTF">2021-08-05T13:18:17Z</dcterms:created>
  <dcterms:modified xsi:type="dcterms:W3CDTF">2022-12-23T03:29:25Z</dcterms:modified>
</cp:coreProperties>
</file>